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Objects="1" showGuides="1">
      <p:cViewPr varScale="1">
        <p:scale>
          <a:sx n="119" d="100"/>
          <a:sy n="119" d="100"/>
        </p:scale>
        <p:origin x="-2016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43A4F-E81E-674E-962D-11EF3413EFAC}" type="datetimeFigureOut">
              <a:rPr lang="ja-JP" altLang="en-US" smtClean="0"/>
              <a:pPr/>
              <a:t>13/05/2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EA32D-5343-AD45-A268-ADCF7E5798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43A4F-E81E-674E-962D-11EF3413EFAC}" type="datetimeFigureOut">
              <a:rPr lang="ja-JP" altLang="en-US" smtClean="0"/>
              <a:pPr/>
              <a:t>13/05/2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EA32D-5343-AD45-A268-ADCF7E5798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43A4F-E81E-674E-962D-11EF3413EFAC}" type="datetimeFigureOut">
              <a:rPr lang="ja-JP" altLang="en-US" smtClean="0"/>
              <a:pPr/>
              <a:t>13/05/2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EA32D-5343-AD45-A268-ADCF7E5798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43A4F-E81E-674E-962D-11EF3413EFAC}" type="datetimeFigureOut">
              <a:rPr lang="ja-JP" altLang="en-US" smtClean="0"/>
              <a:pPr/>
              <a:t>13/05/2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EA32D-5343-AD45-A268-ADCF7E5798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43A4F-E81E-674E-962D-11EF3413EFAC}" type="datetimeFigureOut">
              <a:rPr lang="ja-JP" altLang="en-US" smtClean="0"/>
              <a:pPr/>
              <a:t>13/05/2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EA32D-5343-AD45-A268-ADCF7E5798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43A4F-E81E-674E-962D-11EF3413EFAC}" type="datetimeFigureOut">
              <a:rPr lang="ja-JP" altLang="en-US" smtClean="0"/>
              <a:pPr/>
              <a:t>13/05/2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EA32D-5343-AD45-A268-ADCF7E5798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43A4F-E81E-674E-962D-11EF3413EFAC}" type="datetimeFigureOut">
              <a:rPr lang="ja-JP" altLang="en-US" smtClean="0"/>
              <a:pPr/>
              <a:t>13/05/21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EA32D-5343-AD45-A268-ADCF7E5798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43A4F-E81E-674E-962D-11EF3413EFAC}" type="datetimeFigureOut">
              <a:rPr lang="ja-JP" altLang="en-US" smtClean="0"/>
              <a:pPr/>
              <a:t>13/05/21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EA32D-5343-AD45-A268-ADCF7E5798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43A4F-E81E-674E-962D-11EF3413EFAC}" type="datetimeFigureOut">
              <a:rPr lang="ja-JP" altLang="en-US" smtClean="0"/>
              <a:pPr/>
              <a:t>13/05/21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EA32D-5343-AD45-A268-ADCF7E5798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43A4F-E81E-674E-962D-11EF3413EFAC}" type="datetimeFigureOut">
              <a:rPr lang="ja-JP" altLang="en-US" smtClean="0"/>
              <a:pPr/>
              <a:t>13/05/2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EA32D-5343-AD45-A268-ADCF7E5798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343A4F-E81E-674E-962D-11EF3413EFAC}" type="datetimeFigureOut">
              <a:rPr lang="ja-JP" altLang="en-US" smtClean="0"/>
              <a:pPr/>
              <a:t>13/05/21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FEA32D-5343-AD45-A268-ADCF7E5798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343A4F-E81E-674E-962D-11EF3413EFAC}" type="datetimeFigureOut">
              <a:rPr lang="ja-JP" altLang="en-US" smtClean="0"/>
              <a:pPr/>
              <a:t>13/05/21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FEA32D-5343-AD45-A268-ADCF7E5798D7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/>
          <p:cNvGrpSpPr/>
          <p:nvPr/>
        </p:nvGrpSpPr>
        <p:grpSpPr>
          <a:xfrm>
            <a:off x="332656" y="645380"/>
            <a:ext cx="6172200" cy="8031076"/>
            <a:chOff x="522482" y="403354"/>
            <a:chExt cx="6172200" cy="8031076"/>
          </a:xfrm>
        </p:grpSpPr>
        <p:grpSp>
          <p:nvGrpSpPr>
            <p:cNvPr id="15" name="図形グループ 14"/>
            <p:cNvGrpSpPr/>
            <p:nvPr/>
          </p:nvGrpSpPr>
          <p:grpSpPr>
            <a:xfrm>
              <a:off x="1314481" y="403354"/>
              <a:ext cx="5380201" cy="8031076"/>
              <a:chOff x="1348609" y="893907"/>
              <a:chExt cx="5380201" cy="8031076"/>
            </a:xfrm>
          </p:grpSpPr>
          <p:pic>
            <p:nvPicPr>
              <p:cNvPr id="5" name="図 4" descr="MAlign_11078618.mgd.pdf"/>
              <p:cNvPicPr>
                <a:picLocks noChangeAspect="1"/>
              </p:cNvPicPr>
              <p:nvPr/>
            </p:nvPicPr>
            <p:blipFill>
              <a:blip r:embed="rId2"/>
              <a:srcRect l="17019" t="7187" r="5115"/>
              <a:stretch>
                <a:fillRect/>
              </a:stretch>
            </p:blipFill>
            <p:spPr>
              <a:xfrm>
                <a:off x="1348609" y="893907"/>
                <a:ext cx="5380201" cy="8031076"/>
              </a:xfrm>
              <a:prstGeom prst="rect">
                <a:avLst/>
              </a:prstGeom>
            </p:spPr>
          </p:pic>
          <p:sp>
            <p:nvSpPr>
              <p:cNvPr id="14" name="正方形/長方形 13"/>
              <p:cNvSpPr/>
              <p:nvPr/>
            </p:nvSpPr>
            <p:spPr>
              <a:xfrm>
                <a:off x="5619230" y="5594149"/>
                <a:ext cx="85726" cy="1006475"/>
              </a:xfrm>
              <a:prstGeom prst="rect">
                <a:avLst/>
              </a:prstGeom>
              <a:noFill/>
              <a:ln w="19050" cap="flat" cmpd="sng" algn="ctr">
                <a:solidFill>
                  <a:srgbClr val="FF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18" name="テキスト ボックス 5"/>
            <p:cNvSpPr txBox="1"/>
            <p:nvPr/>
          </p:nvSpPr>
          <p:spPr>
            <a:xfrm>
              <a:off x="533400" y="1614524"/>
              <a:ext cx="1077718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080"/>
                </a:lnSpc>
              </a:pPr>
              <a:r>
                <a:rPr kumimoji="1"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Rice</a:t>
              </a: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Sorghum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Soybean</a:t>
              </a: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Arabidopsis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Medicago</a:t>
              </a:r>
              <a:endParaRPr kumimoji="1" lang="en-US" altLang="ja-JP" sz="9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Monaco"/>
                <a:cs typeface="Monaco"/>
              </a:endParaRP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Castor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Populus</a:t>
              </a:r>
              <a:endParaRPr kumimoji="1" lang="en-US" altLang="ja-JP" sz="9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Monaco"/>
                <a:cs typeface="Monaco"/>
              </a:endParaRPr>
            </a:p>
          </p:txBody>
        </p:sp>
        <p:sp>
          <p:nvSpPr>
            <p:cNvPr id="19" name="テキスト ボックス 5"/>
            <p:cNvSpPr txBox="1"/>
            <p:nvPr/>
          </p:nvSpPr>
          <p:spPr>
            <a:xfrm>
              <a:off x="522482" y="2757524"/>
              <a:ext cx="1077718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080"/>
                </a:lnSpc>
              </a:pPr>
              <a:r>
                <a:rPr kumimoji="1"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Rice</a:t>
              </a: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Sorghum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Soybean</a:t>
              </a: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Arabidopsis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Medicago</a:t>
              </a:r>
              <a:endParaRPr kumimoji="1" lang="en-US" altLang="ja-JP" sz="9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Monaco"/>
                <a:cs typeface="Monaco"/>
              </a:endParaRP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Castor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Populus</a:t>
              </a:r>
              <a:endParaRPr kumimoji="1" lang="en-US" altLang="ja-JP" sz="9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Monaco"/>
                <a:cs typeface="Monaco"/>
              </a:endParaRPr>
            </a:p>
          </p:txBody>
        </p:sp>
        <p:sp>
          <p:nvSpPr>
            <p:cNvPr id="20" name="テキスト ボックス 5"/>
            <p:cNvSpPr txBox="1"/>
            <p:nvPr/>
          </p:nvSpPr>
          <p:spPr>
            <a:xfrm>
              <a:off x="522482" y="3927834"/>
              <a:ext cx="1077718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080"/>
                </a:lnSpc>
              </a:pPr>
              <a:r>
                <a:rPr kumimoji="1"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Rice</a:t>
              </a: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Sorghum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Soybean</a:t>
              </a: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Arabidopsis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Medicago</a:t>
              </a:r>
              <a:endParaRPr kumimoji="1" lang="en-US" altLang="ja-JP" sz="9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Monaco"/>
                <a:cs typeface="Monaco"/>
              </a:endParaRP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Castor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Populus</a:t>
              </a:r>
              <a:endParaRPr kumimoji="1" lang="en-US" altLang="ja-JP" sz="9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Monaco"/>
                <a:cs typeface="Monaco"/>
              </a:endParaRPr>
            </a:p>
          </p:txBody>
        </p:sp>
        <p:sp>
          <p:nvSpPr>
            <p:cNvPr id="21" name="テキスト ボックス 5"/>
            <p:cNvSpPr txBox="1"/>
            <p:nvPr/>
          </p:nvSpPr>
          <p:spPr>
            <a:xfrm>
              <a:off x="533400" y="5070834"/>
              <a:ext cx="1077718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080"/>
                </a:lnSpc>
              </a:pPr>
              <a:r>
                <a:rPr kumimoji="1"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Rice</a:t>
              </a: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Sorghum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Soybean</a:t>
              </a: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Arabidopsis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Medicago</a:t>
              </a:r>
              <a:endParaRPr kumimoji="1" lang="en-US" altLang="ja-JP" sz="9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Monaco"/>
                <a:cs typeface="Monaco"/>
              </a:endParaRP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Castor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Populus</a:t>
              </a:r>
              <a:endParaRPr kumimoji="1" lang="en-US" altLang="ja-JP" sz="9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Monaco"/>
                <a:cs typeface="Monaco"/>
              </a:endParaRPr>
            </a:p>
          </p:txBody>
        </p:sp>
        <p:sp>
          <p:nvSpPr>
            <p:cNvPr id="22" name="テキスト ボックス 5"/>
            <p:cNvSpPr txBox="1"/>
            <p:nvPr/>
          </p:nvSpPr>
          <p:spPr>
            <a:xfrm>
              <a:off x="522482" y="6224975"/>
              <a:ext cx="1077718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080"/>
                </a:lnSpc>
              </a:pPr>
              <a:r>
                <a:rPr kumimoji="1"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Rice</a:t>
              </a: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Sorghum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Soybean</a:t>
              </a: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Arabidopsis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Medicago</a:t>
              </a:r>
              <a:endParaRPr kumimoji="1" lang="en-US" altLang="ja-JP" sz="9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Monaco"/>
                <a:cs typeface="Monaco"/>
              </a:endParaRP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Castor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Populus</a:t>
              </a:r>
              <a:endParaRPr kumimoji="1" lang="en-US" altLang="ja-JP" sz="9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Monaco"/>
                <a:cs typeface="Monaco"/>
              </a:endParaRPr>
            </a:p>
          </p:txBody>
        </p:sp>
        <p:sp>
          <p:nvSpPr>
            <p:cNvPr id="23" name="テキスト ボックス 5"/>
            <p:cNvSpPr txBox="1"/>
            <p:nvPr/>
          </p:nvSpPr>
          <p:spPr>
            <a:xfrm>
              <a:off x="522482" y="7362948"/>
              <a:ext cx="1077718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080"/>
                </a:lnSpc>
              </a:pPr>
              <a:r>
                <a:rPr kumimoji="1"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Rice</a:t>
              </a: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Sorghum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Soybean</a:t>
              </a: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Arabidopsis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Medicago</a:t>
              </a:r>
              <a:endParaRPr kumimoji="1" lang="en-US" altLang="ja-JP" sz="9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Monaco"/>
                <a:cs typeface="Monaco"/>
              </a:endParaRP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Castor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Populus</a:t>
              </a:r>
              <a:endParaRPr kumimoji="1" lang="en-US" altLang="ja-JP" sz="9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Monaco"/>
                <a:cs typeface="Monaco"/>
              </a:endParaRPr>
            </a:p>
          </p:txBody>
        </p:sp>
        <p:sp>
          <p:nvSpPr>
            <p:cNvPr id="24" name="テキスト ボックス 5"/>
            <p:cNvSpPr txBox="1"/>
            <p:nvPr/>
          </p:nvSpPr>
          <p:spPr>
            <a:xfrm>
              <a:off x="522482" y="471524"/>
              <a:ext cx="1077718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080"/>
                </a:lnSpc>
              </a:pPr>
              <a:r>
                <a:rPr kumimoji="1"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Rice</a:t>
              </a: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Sorghum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Soybean</a:t>
              </a: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Arabidopsis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Medicago</a:t>
              </a:r>
              <a:endParaRPr kumimoji="1" lang="en-US" altLang="ja-JP" sz="9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Monaco"/>
                <a:cs typeface="Monaco"/>
              </a:endParaRPr>
            </a:p>
            <a:p>
              <a:pPr>
                <a:lnSpc>
                  <a:spcPts val="1080"/>
                </a:lnSpc>
              </a:pPr>
              <a:r>
                <a:rPr lang="en-US" altLang="ja-JP" sz="9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Castor</a:t>
              </a:r>
            </a:p>
            <a:p>
              <a:pPr>
                <a:lnSpc>
                  <a:spcPts val="1080"/>
                </a:lnSpc>
              </a:pPr>
              <a:r>
                <a:rPr kumimoji="1" lang="en-US" altLang="ja-JP" sz="900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Monaco"/>
                  <a:cs typeface="Monaco"/>
                </a:rPr>
                <a:t>Populus</a:t>
              </a:r>
              <a:endParaRPr kumimoji="1" lang="en-US" altLang="ja-JP" sz="9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Monaco"/>
                <a:cs typeface="Monaco"/>
              </a:endParaRPr>
            </a:p>
          </p:txBody>
        </p:sp>
      </p:grpSp>
      <p:sp>
        <p:nvSpPr>
          <p:cNvPr id="26" name="テキスト ボックス 25"/>
          <p:cNvSpPr txBox="1"/>
          <p:nvPr/>
        </p:nvSpPr>
        <p:spPr>
          <a:xfrm>
            <a:off x="2014563" y="262743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</TotalTime>
  <Words>49</Words>
  <Application>Microsoft Macintosh PowerPoint</Application>
  <PresentationFormat>On-screen Show (4:3)</PresentationFormat>
  <Paragraphs>4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Mac 108</dc:creator>
  <cp:lastModifiedBy>Muluneh Tamiru Oli</cp:lastModifiedBy>
  <cp:revision>11</cp:revision>
  <cp:lastPrinted>2013-05-20T06:50:01Z</cp:lastPrinted>
  <dcterms:created xsi:type="dcterms:W3CDTF">2012-12-18T08:11:25Z</dcterms:created>
  <dcterms:modified xsi:type="dcterms:W3CDTF">2013-05-21T01:11:16Z</dcterms:modified>
</cp:coreProperties>
</file>